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79"/>
    <p:restoredTop sz="95794"/>
  </p:normalViewPr>
  <p:slideViewPr>
    <p:cSldViewPr snapToGrid="0">
      <p:cViewPr>
        <p:scale>
          <a:sx n="100" d="100"/>
          <a:sy n="100" d="100"/>
        </p:scale>
        <p:origin x="1000" y="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EECA4A-3D73-D1A4-78AD-7EBD63534E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F0CCB1-8666-D395-5173-4C10611A07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D1B13-91EB-9BB1-835B-009674D59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061F42-141D-2851-2B6C-D36514C63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0219CB-5A63-2DE1-526B-3519E1C2A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84243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8B6FA-E7D5-6E6E-1955-035335A49A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3C6E3C-143D-1EB6-8905-009EF125BC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D912D9-5BEF-1880-A3F9-9733B38F1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72A760-88A5-383D-D320-015A54699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F3C551-91C4-4CB0-4FF9-A04681165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82403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ED99E8-AE65-0AFF-BAC1-52EFD56798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3A2984-E0A8-09F9-2BD8-A80E61291B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E36802-EAF6-75BD-AA6F-9E2673B10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5F1B8-C76F-80D5-FEE5-CB60CD5CB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431F3-A347-B345-9368-3F5287545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00915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8ACE42-A5CA-68F2-ECED-66AA1E944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DF52F-2EA5-2864-7775-74F2CD4F04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8000A3-7E38-C180-715F-C808FB3FB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9145C1-067C-972D-3F23-54BC60847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454690-7D78-4957-6B98-6B3B13364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04768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565B70-DD76-0E4C-D4A8-5B72987BA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90748-A373-14EB-31E4-52B410904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6E67BD-8C0B-6EA6-E769-05D7CC96C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820BA8-6D3D-F67E-2D43-CC39BCAC5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D3C513-4E8E-5181-F980-574C4F8ED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132784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4EDC0-C874-D6A5-78CF-411C01CD7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235888-892E-FEED-E82A-FF32726F2C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0DB91E-726B-1774-9FF9-CEFCCB80B3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B7DC32-E42D-8768-8506-EC2626991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380D50-0E4C-6681-E080-B091646C5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C1B012-4B6E-7D5C-8916-E2A9234BC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525749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1A015D-B427-4DC7-1BAF-59691FD99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69C107-46CE-6C8E-ED62-6C708525B3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7938A9-C900-DA00-C822-C308B5B046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C1DC71-A455-9F58-F9AF-97949E735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F455BC-F32C-C72B-0EE0-7C7E917042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F69624-D4BC-9179-8A01-4C7CA54A3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545DC9-541F-F8D3-0330-B47B157D7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58E878-D9DB-F020-1164-73BB1813F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161536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E20A8-4061-DE31-26A4-266EFF14BF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1767EE-6980-AC42-253F-91521B627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9166E3-B309-46B2-AAA6-98A1FDE56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7EED66-1171-2CCA-FD55-B95C7DC17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2467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343F2F-D1DF-F541-0756-A97634050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8978C0-DC79-3C8B-C431-A0F0107F1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C9FB6C-773D-FAC7-C4F9-38A816E1B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938852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29FD4-76A5-9C55-0CB3-FAEBD9308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678E3B-D351-9143-941F-53674EDBC9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4627E8-72DF-A79F-7358-23B57FD93D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AC0C0E-A07A-A827-04A4-2EB54574F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D3B92B-370E-9AB6-3E91-57384E4C6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BB8CF-7664-FC8F-870D-870BEF712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54523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48558-B97A-F563-A8AE-3D701FF72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E8E802-98B0-D274-50F0-8C6D1ACFB7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62B993-3698-BE61-BEB4-34D34BF8C7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9255D9-B9D9-AAD5-0595-A0016E371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2E8570-81F8-5ABF-4C8D-70B3D99F6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C1F59C-F3C5-F0ED-ED63-6EAC9BECD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00714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EF5B7E-06CA-84BC-FB2F-D4D74977B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A87488-F455-7754-0886-2568F9A5D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4C9544-DC66-07C0-E4E1-F8C80BDD1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AF576-5CD4-6843-8F17-1CBCC94475AA}" type="datetimeFigureOut">
              <a:rPr lang="en-TH" smtClean="0"/>
              <a:t>19/2/2024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B3751-54C6-C1CE-3023-C14CC0919D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B3184-07C4-B968-1DF1-70B9D5BE1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ED3D4-8D26-4C4D-9608-C7B16B89C66A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150564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C765448-B6C1-07EA-58D3-6E45E7E8D9F0}"/>
              </a:ext>
            </a:extLst>
          </p:cNvPr>
          <p:cNvSpPr txBox="1"/>
          <p:nvPr/>
        </p:nvSpPr>
        <p:spPr>
          <a:xfrm>
            <a:off x="0" y="1828801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TH" sz="32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TH" sz="3200" b="1" dirty="0">
                <a:latin typeface="Arial" panose="020B0604020202020204" pitchFamily="34" charset="0"/>
                <a:cs typeface="Arial" panose="020B0604020202020204" pitchFamily="34" charset="0"/>
              </a:rPr>
              <a:t>ile 9: Figure S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103945-2174-02F5-C8F5-0BDD9B6CCDBC}"/>
              </a:ext>
            </a:extLst>
          </p:cNvPr>
          <p:cNvSpPr txBox="1"/>
          <p:nvPr/>
        </p:nvSpPr>
        <p:spPr>
          <a:xfrm>
            <a:off x="0" y="2874345"/>
            <a:ext cx="12192000" cy="19514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ample</a:t>
            </a:r>
            <a:r>
              <a:rPr lang="en-US" sz="2800" b="1" kern="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RPA amplicons targeting </a:t>
            </a:r>
          </a:p>
          <a:p>
            <a:pPr algn="ctr">
              <a:lnSpc>
                <a:spcPct val="150000"/>
              </a:lnSpc>
            </a:pP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uman actin beta gene (</a:t>
            </a:r>
            <a:r>
              <a:rPr lang="en-US" sz="2800" b="1" i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CTB</a:t>
            </a: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</a:p>
          <a:p>
            <a:pPr algn="ctr">
              <a:lnSpc>
                <a:spcPct val="150000"/>
              </a:lnSpc>
            </a:pP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T20b</a:t>
            </a:r>
            <a:r>
              <a:rPr lang="en-US" sz="2800" b="1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GsCPC2 (</a:t>
            </a:r>
            <a:r>
              <a:rPr lang="en-US" sz="2800" b="1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CPC2</a:t>
            </a:r>
            <a:r>
              <a:rPr lang="en-US" sz="28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TH" sz="2800" b="1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5840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1F704B3-C14F-54DE-220B-D33FD74FF729}"/>
              </a:ext>
            </a:extLst>
          </p:cNvPr>
          <p:cNvGrpSpPr/>
          <p:nvPr/>
        </p:nvGrpSpPr>
        <p:grpSpPr>
          <a:xfrm>
            <a:off x="1887672" y="910823"/>
            <a:ext cx="7772400" cy="5036353"/>
            <a:chOff x="1887672" y="910823"/>
            <a:chExt cx="7772400" cy="5036353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2083C0F-2D5E-EDCB-9FBD-BE7B82EA43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87672" y="910823"/>
              <a:ext cx="7772400" cy="5036353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541A5C7-143F-EC05-D6CE-A6B40614991D}"/>
                </a:ext>
              </a:extLst>
            </p:cNvPr>
            <p:cNvSpPr txBox="1"/>
            <p:nvPr/>
          </p:nvSpPr>
          <p:spPr>
            <a:xfrm>
              <a:off x="6121400" y="4775200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TH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7103957-5EEA-9DFE-84B3-7FA23D0A6204}"/>
                </a:ext>
              </a:extLst>
            </p:cNvPr>
            <p:cNvSpPr txBox="1"/>
            <p:nvPr/>
          </p:nvSpPr>
          <p:spPr>
            <a:xfrm>
              <a:off x="9308694" y="4747256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TH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463DF963-9C7F-04BF-3534-F23C17DF4814}"/>
              </a:ext>
            </a:extLst>
          </p:cNvPr>
          <p:cNvSpPr txBox="1"/>
          <p:nvPr/>
        </p:nvSpPr>
        <p:spPr>
          <a:xfrm>
            <a:off x="571647" y="5377020"/>
            <a:ext cx="11423130" cy="13234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TH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9: Figure S5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amples of RPA amplicons targeting the 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hACT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gene (221 bp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sCPC2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(378 bp,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B)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at were amplified from copro-DNA samples using RPA. The target amplicons are indicated by red arrows.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TH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A</a:t>
            </a:r>
            <a:r>
              <a:rPr lang="en-TH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ne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: 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 kb ladder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ne 1: NTC, Lane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 </a:t>
            </a:r>
            <a:r>
              <a:rPr lang="en-TH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–</a:t>
            </a:r>
            <a:r>
              <a:rPr lang="en-TH" sz="16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8</a:t>
            </a:r>
            <a:r>
              <a:rPr lang="en-TH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mple number 1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, Lane 9: postive control. L</a:t>
            </a:r>
            <a:r>
              <a:rPr lang="en-US" sz="16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es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–5 show the target amplicons, in contrast to lanes 6–8, where there are no target amplicons. </a:t>
            </a:r>
            <a:r>
              <a:rPr lang="en-TH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B</a:t>
            </a:r>
            <a:r>
              <a:rPr lang="en-TH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ne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: 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 kb ladder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ane 1: NTC, Lanes </a:t>
            </a:r>
            <a:r>
              <a:rPr lang="en-TH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5</a:t>
            </a:r>
            <a:r>
              <a:rPr lang="en-TH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ample number 1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TH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.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nes 2–5 show the target amplicons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66CBD0-481E-874E-8C49-484A8E6EC3E3}"/>
              </a:ext>
            </a:extLst>
          </p:cNvPr>
          <p:cNvSpPr txBox="1"/>
          <p:nvPr/>
        </p:nvSpPr>
        <p:spPr>
          <a:xfrm>
            <a:off x="1081946" y="293207"/>
            <a:ext cx="9735871" cy="872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TH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9: Figure S5. </a:t>
            </a:r>
            <a:r>
              <a:rPr lang="en-TH" dirty="0">
                <a:latin typeface="Arial" panose="020B0604020202020204" pitchFamily="34" charset="0"/>
                <a:cs typeface="Arial" panose="020B0604020202020204" pitchFamily="34" charset="0"/>
              </a:rPr>
              <a:t>Gel electropheresis of RPA products targeting human actin beta gene (</a:t>
            </a:r>
            <a:r>
              <a:rPr lang="en-TH" i="1" dirty="0">
                <a:latin typeface="Arial" panose="020B0604020202020204" pitchFamily="34" charset="0"/>
                <a:cs typeface="Arial" panose="020B0604020202020204" pitchFamily="34" charset="0"/>
              </a:rPr>
              <a:t>hACTB</a:t>
            </a:r>
            <a:r>
              <a:rPr lang="en-TH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ET20b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–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GsCPC2</a:t>
            </a:r>
            <a:r>
              <a:rPr lang="en-TH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GsCPC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959364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189</Words>
  <Application>Microsoft Macintosh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20</cp:revision>
  <dcterms:created xsi:type="dcterms:W3CDTF">2023-07-20T04:33:06Z</dcterms:created>
  <dcterms:modified xsi:type="dcterms:W3CDTF">2024-02-19T07:52:59Z</dcterms:modified>
</cp:coreProperties>
</file>